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726"/>
  </p:normalViewPr>
  <p:slideViewPr>
    <p:cSldViewPr snapToGrid="0">
      <p:cViewPr varScale="1">
        <p:scale>
          <a:sx n="102" d="100"/>
          <a:sy n="102" d="100"/>
        </p:scale>
        <p:origin x="1400" y="4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6690A30-F21C-F46F-75A2-9CF008B13AF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5686ACB8-EBAF-038B-05FA-9875B8FC1F7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3716703-D335-720F-8486-4737A1B900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CEB67-CF38-A442-883F-26FE42A37751}" type="datetimeFigureOut">
              <a:rPr kumimoji="1" lang="ja-JP" altLang="en-US" smtClean="0"/>
              <a:t>2025/8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38F37B0-ACBA-B5A8-06F7-E4AB2102F8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E53E30B-0707-A8A1-487D-119AE19825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B0AC-A360-1B4C-896F-7E58C996FC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072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9C0E20C-CA42-D637-8DB5-C02EF19E7D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68D8537-BE79-AD38-BAB2-91E3B585E4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467803A-FB92-D05D-7FEA-A05E8FFBCF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CEB67-CF38-A442-883F-26FE42A37751}" type="datetimeFigureOut">
              <a:rPr kumimoji="1" lang="ja-JP" altLang="en-US" smtClean="0"/>
              <a:t>2025/8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1B88C16-CFFA-6107-4A68-75F5DA5DED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A6E924E-D5D5-7764-0677-4A9D5D754D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B0AC-A360-1B4C-896F-7E58C996FC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78039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CC42875D-AFB0-411E-A2BA-1905EE1B219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E1509AD-0807-1A0E-D282-60166452D4F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0BFDCA4-BEC3-FD63-E3E3-27C4C7A2A6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CEB67-CF38-A442-883F-26FE42A37751}" type="datetimeFigureOut">
              <a:rPr kumimoji="1" lang="ja-JP" altLang="en-US" smtClean="0"/>
              <a:t>2025/8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4C49870-C205-FC6F-68AD-2A1FFE7787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A5365C3-6B4C-DE20-0392-529C0F827E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B0AC-A360-1B4C-896F-7E58C996FC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25404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327ABDF-F6EC-9476-8A9D-96ABEAA38B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6BAD76A-5C40-24D9-B1A8-450EB4E8F1A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8342B25-5D2A-998F-5461-F573C32852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CEB67-CF38-A442-883F-26FE42A37751}" type="datetimeFigureOut">
              <a:rPr kumimoji="1" lang="ja-JP" altLang="en-US" smtClean="0"/>
              <a:t>2025/8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EFB6A21-A6F8-FF54-3D18-CE77E80809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F0CF7EE-BEF3-92D7-0175-A84B7141B8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B0AC-A360-1B4C-896F-7E58C996FC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26751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0C217F0-BC23-FE46-8643-3055441770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F36909E-C30A-C191-281C-7236F10FB8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B876B26-0D33-2161-6E4D-497CEDED68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CEB67-CF38-A442-883F-26FE42A37751}" type="datetimeFigureOut">
              <a:rPr kumimoji="1" lang="ja-JP" altLang="en-US" smtClean="0"/>
              <a:t>2025/8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600F707-8366-7112-843A-3B82CAD609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7717F89-C891-9E53-E43A-78C1754DCC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B0AC-A360-1B4C-896F-7E58C996FC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1458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F39193A-A04D-2475-4F82-0595F60152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C4BFF74-3ADE-0797-ACCB-102C2873A1F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FA0B138-B17B-3F7B-1B93-93EF7A96413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E133203-4010-7177-0100-1F6CD38426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CEB67-CF38-A442-883F-26FE42A37751}" type="datetimeFigureOut">
              <a:rPr kumimoji="1" lang="ja-JP" altLang="en-US" smtClean="0"/>
              <a:t>2025/8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2D7FFAD-6E92-F5DC-AA81-7BAFE1EF6E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3B4C2D3-793F-8B82-2739-F2D1E20739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B0AC-A360-1B4C-896F-7E58C996FC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55662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663694D-FF9F-B225-2F30-B18FF27B8E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5A5ACBC-9AB6-E3BD-7AC6-3CE968703FE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624243C-CEFA-7F2C-DFE4-96B59A78F8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D08F6715-A5CF-74AB-71E0-E6664F54E02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C784C6E5-B5FB-9E25-FABB-918D20B617A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C5F10785-FD70-B3A2-BEE2-4D1FF9B8C5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CEB67-CF38-A442-883F-26FE42A37751}" type="datetimeFigureOut">
              <a:rPr kumimoji="1" lang="ja-JP" altLang="en-US" smtClean="0"/>
              <a:t>2025/8/2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E10EC086-0FEE-7964-7B35-604CFA0EA5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CB677809-A6AC-B597-3127-61CCB67FBA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B0AC-A360-1B4C-896F-7E58C996FC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65023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1911537-C1C5-EFC3-5368-6A94C767D7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F82FCEE8-565B-6EB0-FF9F-6274B68E71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CEB67-CF38-A442-883F-26FE42A37751}" type="datetimeFigureOut">
              <a:rPr kumimoji="1" lang="ja-JP" altLang="en-US" smtClean="0"/>
              <a:t>2025/8/2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06D249E0-127B-3332-5F25-2902E29CCF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EF3828D0-8350-C8DF-DD03-3518D34C69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B0AC-A360-1B4C-896F-7E58C996FC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13432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64D49CCA-1480-8857-C078-5B9482E385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CEB67-CF38-A442-883F-26FE42A37751}" type="datetimeFigureOut">
              <a:rPr kumimoji="1" lang="ja-JP" altLang="en-US" smtClean="0"/>
              <a:t>2025/8/2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866FD4EF-F9E7-9E0B-4DD9-06D81B22EF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968AF59D-489D-D59E-87DB-B4D6E52C18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B0AC-A360-1B4C-896F-7E58C996FC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05513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7C072F7-1765-691D-B3AB-9297660B96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E5F3524-5E70-82FB-B123-10A36C1F178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579264C-7F56-8A93-E7F1-3053341E6F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EAA2444-7D94-A44C-8AC1-58918E0FEA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CEB67-CF38-A442-883F-26FE42A37751}" type="datetimeFigureOut">
              <a:rPr kumimoji="1" lang="ja-JP" altLang="en-US" smtClean="0"/>
              <a:t>2025/8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5F3F11E-EA59-B49C-E1FC-AD9E7B52FC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29FEBAE-F686-6FF5-CB27-35FB74985E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B0AC-A360-1B4C-896F-7E58C996FC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46005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3AAC632-B662-908F-FDC3-F6A6FD5174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1E08E097-7042-3291-991B-D36A7F6BCF3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7823E6B-A9E1-61F6-6CFD-49CF594BCD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13785A6-E051-3060-1BF2-9040757F87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CEB67-CF38-A442-883F-26FE42A37751}" type="datetimeFigureOut">
              <a:rPr kumimoji="1" lang="ja-JP" altLang="en-US" smtClean="0"/>
              <a:t>2025/8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1CD2E68-BE62-F724-7BBD-4CE7483367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C207093-5FE4-CCE4-D4B2-95AC89E037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B0AC-A360-1B4C-896F-7E58C996FC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04611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3235EA25-8D71-0BBB-7C39-51530399AB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0B23531-E8E5-C680-AB6D-52B99B0B8F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5C09356-4394-3F14-D584-7B4CECC6D7A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B1CEB67-CF38-A442-883F-26FE42A37751}" type="datetimeFigureOut">
              <a:rPr kumimoji="1" lang="ja-JP" altLang="en-US" smtClean="0"/>
              <a:t>2025/8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E58549D-660B-2DA6-53BB-8D5C44513DC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C94490C-BBCF-B1F9-97DF-F25EA832089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C6AB0AC-A360-1B4C-896F-7E58C996FC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40527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図 9">
            <a:extLst>
              <a:ext uri="{FF2B5EF4-FFF2-40B4-BE49-F238E27FC236}">
                <a16:creationId xmlns:a16="http://schemas.microsoft.com/office/drawing/2014/main" id="{E3D5E679-9ADE-EB24-6470-9C288B722B9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86813" y="711410"/>
            <a:ext cx="5995182" cy="4232679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0C09E715-2389-A725-4149-AB117AA3D6C4}"/>
              </a:ext>
            </a:extLst>
          </p:cNvPr>
          <p:cNvSpPr txBox="1"/>
          <p:nvPr/>
        </p:nvSpPr>
        <p:spPr>
          <a:xfrm>
            <a:off x="6701425" y="2643085"/>
            <a:ext cx="231345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latin typeface="Helvetica" pitchFamily="2" charset="0"/>
              </a:rPr>
              <a:t>y</a:t>
            </a:r>
            <a:r>
              <a:rPr kumimoji="1" lang="en-US" altLang="ja-JP" sz="2000" dirty="0">
                <a:latin typeface="Helvetica" pitchFamily="2" charset="0"/>
              </a:rPr>
              <a:t>=0.0005x-0.0219 </a:t>
            </a:r>
            <a:endParaRPr kumimoji="1" lang="ja-JP" altLang="en-US" sz="2000">
              <a:latin typeface="Helvetica" pitchFamily="2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2341B739-37B8-B4E8-DCF1-77A40AA0A9E9}"/>
              </a:ext>
            </a:extLst>
          </p:cNvPr>
          <p:cNvSpPr txBox="1"/>
          <p:nvPr/>
        </p:nvSpPr>
        <p:spPr>
          <a:xfrm>
            <a:off x="4292556" y="5072721"/>
            <a:ext cx="40318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>
                <a:latin typeface="Helvetica" pitchFamily="2" charset="0"/>
              </a:rPr>
              <a:t>Remimazolam</a:t>
            </a:r>
            <a:r>
              <a:rPr kumimoji="1" lang="en-US" altLang="ja-JP" dirty="0">
                <a:latin typeface="Helvetica" pitchFamily="2" charset="0"/>
              </a:rPr>
              <a:t> concentration (ng/mL)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E145130D-E92F-1D8B-3C47-A4CD8A50DE71}"/>
              </a:ext>
            </a:extLst>
          </p:cNvPr>
          <p:cNvSpPr txBox="1"/>
          <p:nvPr/>
        </p:nvSpPr>
        <p:spPr>
          <a:xfrm rot="16200000">
            <a:off x="2639143" y="2643084"/>
            <a:ext cx="9460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Helvetica" pitchFamily="2" charset="0"/>
              </a:rPr>
              <a:t>IS ratio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5AFB0EE-7C1B-61FC-0605-2DBF1C46E8BA}"/>
              </a:ext>
            </a:extLst>
          </p:cNvPr>
          <p:cNvSpPr txBox="1"/>
          <p:nvPr/>
        </p:nvSpPr>
        <p:spPr>
          <a:xfrm>
            <a:off x="3474496" y="5570685"/>
            <a:ext cx="696447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Helvetica" pitchFamily="2" charset="0"/>
              </a:rPr>
              <a:t>Supplemental Figure 1: Calibration curve for </a:t>
            </a:r>
            <a:r>
              <a:rPr lang="en-US" altLang="ja-JP" dirty="0" err="1">
                <a:latin typeface="Helvetica" pitchFamily="2" charset="0"/>
              </a:rPr>
              <a:t>remimazolam</a:t>
            </a:r>
            <a:r>
              <a:rPr lang="en-US" altLang="ja-JP" dirty="0">
                <a:latin typeface="Helvetica" pitchFamily="2" charset="0"/>
              </a:rPr>
              <a:t> concentration measurement </a:t>
            </a:r>
          </a:p>
          <a:p>
            <a:endParaRPr kumimoji="1" lang="en-US" altLang="ja-JP" dirty="0">
              <a:latin typeface="Helvetica" pitchFamily="2" charset="0"/>
            </a:endParaRPr>
          </a:p>
          <a:p>
            <a:r>
              <a:rPr kumimoji="1" lang="en-US" altLang="ja-JP" dirty="0">
                <a:latin typeface="Helvetica" pitchFamily="2" charset="0"/>
              </a:rPr>
              <a:t>IS: </a:t>
            </a:r>
            <a:r>
              <a:rPr lang="en-US" altLang="ja-JP" dirty="0">
                <a:latin typeface="Helvetica" pitchFamily="2" charset="0"/>
              </a:rPr>
              <a:t>internal standard</a:t>
            </a:r>
            <a:r>
              <a:rPr lang="ja-JP" altLang="ja-JP">
                <a:latin typeface="Helvetica" pitchFamily="2" charset="0"/>
              </a:rPr>
              <a:t> </a:t>
            </a:r>
            <a:endParaRPr kumimoji="1" lang="ja-JP" altLang="en-US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507486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26</Words>
  <Application>Microsoft Macintosh PowerPoint</Application>
  <PresentationFormat>ワイド画面</PresentationFormat>
  <Paragraphs>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Helvetica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itoshi Higuchi</dc:creator>
  <cp:lastModifiedBy>Hitoshi Higuchi</cp:lastModifiedBy>
  <cp:revision>6</cp:revision>
  <dcterms:created xsi:type="dcterms:W3CDTF">2025-08-14T02:36:17Z</dcterms:created>
  <dcterms:modified xsi:type="dcterms:W3CDTF">2025-08-27T07:09:05Z</dcterms:modified>
</cp:coreProperties>
</file>